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F5050"/>
    <a:srgbClr val="FF9900"/>
    <a:srgbClr val="FF6600"/>
    <a:srgbClr val="0066FF"/>
    <a:srgbClr val="0000F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BCEBCF1-08B6-49D9-95E8-73B63688EAAF}" v="10" dt="2025-03-27T12:15:14.85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96" autoAdjust="0"/>
    <p:restoredTop sz="94731" autoAdjust="0"/>
  </p:normalViewPr>
  <p:slideViewPr>
    <p:cSldViewPr snapToGrid="0">
      <p:cViewPr>
        <p:scale>
          <a:sx n="214" d="100"/>
          <a:sy n="214" d="100"/>
        </p:scale>
        <p:origin x="420" y="-13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夏樹 石田" userId="8bec109333bfdc70" providerId="LiveId" clId="{BBCEBCF1-08B6-49D9-95E8-73B63688EAAF}"/>
    <pc:docChg chg="undo custSel modSld">
      <pc:chgData name="夏樹 石田" userId="8bec109333bfdc70" providerId="LiveId" clId="{BBCEBCF1-08B6-49D9-95E8-73B63688EAAF}" dt="2025-03-27T12:16:05.374" v="133" actId="732"/>
      <pc:docMkLst>
        <pc:docMk/>
      </pc:docMkLst>
      <pc:sldChg chg="addSp delSp modSp mod">
        <pc:chgData name="夏樹 石田" userId="8bec109333bfdc70" providerId="LiveId" clId="{BBCEBCF1-08B6-49D9-95E8-73B63688EAAF}" dt="2025-03-27T12:16:05.374" v="133" actId="732"/>
        <pc:sldMkLst>
          <pc:docMk/>
          <pc:sldMk cId="4070247096" sldId="286"/>
        </pc:sldMkLst>
        <pc:spChg chg="del">
          <ac:chgData name="夏樹 石田" userId="8bec109333bfdc70" providerId="LiveId" clId="{BBCEBCF1-08B6-49D9-95E8-73B63688EAAF}" dt="2025-03-27T12:05:59.926" v="1" actId="478"/>
          <ac:spMkLst>
            <pc:docMk/>
            <pc:sldMk cId="4070247096" sldId="286"/>
            <ac:spMk id="2" creationId="{3717089E-96F3-8407-745C-E8A3022BFCFE}"/>
          </ac:spMkLst>
        </pc:spChg>
        <pc:spChg chg="mod">
          <ac:chgData name="夏樹 石田" userId="8bec109333bfdc70" providerId="LiveId" clId="{BBCEBCF1-08B6-49D9-95E8-73B63688EAAF}" dt="2025-03-27T12:11:17.685" v="82" actId="1037"/>
          <ac:spMkLst>
            <pc:docMk/>
            <pc:sldMk cId="4070247096" sldId="286"/>
            <ac:spMk id="15" creationId="{7337B87A-5958-8E6A-3A33-5A0D5069942F}"/>
          </ac:spMkLst>
        </pc:spChg>
        <pc:spChg chg="add mod">
          <ac:chgData name="夏樹 石田" userId="8bec109333bfdc70" providerId="LiveId" clId="{BBCEBCF1-08B6-49D9-95E8-73B63688EAAF}" dt="2025-03-27T12:13:37.564" v="119" actId="1035"/>
          <ac:spMkLst>
            <pc:docMk/>
            <pc:sldMk cId="4070247096" sldId="286"/>
            <ac:spMk id="17" creationId="{BE3D1BCE-4A5F-CE89-5921-08B797A43DB4}"/>
          </ac:spMkLst>
        </pc:spChg>
        <pc:spChg chg="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18" creationId="{3DCC1872-36CA-622B-1667-A39EA8AB305A}"/>
          </ac:spMkLst>
        </pc:spChg>
        <pc:spChg chg="add 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24" creationId="{45AEC910-7ED2-94FD-E0CD-8D7B716B2BE0}"/>
          </ac:spMkLst>
        </pc:spChg>
        <pc:spChg chg="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25" creationId="{5A2B3BDB-8C88-0288-7F18-BD69828A66B8}"/>
          </ac:spMkLst>
        </pc:spChg>
        <pc:spChg chg="add mod">
          <ac:chgData name="夏樹 石田" userId="8bec109333bfdc70" providerId="LiveId" clId="{BBCEBCF1-08B6-49D9-95E8-73B63688EAAF}" dt="2025-03-27T12:13:37.564" v="119" actId="1035"/>
          <ac:spMkLst>
            <pc:docMk/>
            <pc:sldMk cId="4070247096" sldId="286"/>
            <ac:spMk id="28" creationId="{233CA96D-13B3-565F-0CDE-1EFBFA9FB145}"/>
          </ac:spMkLst>
        </pc:spChg>
        <pc:spChg chg="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29" creationId="{8A96D522-9CF8-F7A5-404C-54CD1949DBFE}"/>
          </ac:spMkLst>
        </pc:spChg>
        <pc:spChg chg="add 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31" creationId="{1C91B18F-BBC2-7CAA-BA25-D0D260BAA391}"/>
          </ac:spMkLst>
        </pc:spChg>
        <pc:spChg chg="add 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32" creationId="{6E5F959F-3ACB-5BC4-AABC-BF8E8F923ABF}"/>
          </ac:spMkLst>
        </pc:spChg>
        <pc:spChg chg="add mod">
          <ac:chgData name="夏樹 石田" userId="8bec109333bfdc70" providerId="LiveId" clId="{BBCEBCF1-08B6-49D9-95E8-73B63688EAAF}" dt="2025-03-27T12:13:37.564" v="119" actId="1035"/>
          <ac:spMkLst>
            <pc:docMk/>
            <pc:sldMk cId="4070247096" sldId="286"/>
            <ac:spMk id="33" creationId="{621AD6D7-74C9-E493-D97F-3E77BB61C4A5}"/>
          </ac:spMkLst>
        </pc:spChg>
        <pc:spChg chg="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34" creationId="{0B8E3E38-4512-C712-E098-7A7F989C9864}"/>
          </ac:spMkLst>
        </pc:spChg>
        <pc:spChg chg="add 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35" creationId="{BC7E063E-7E85-121D-35B7-B8859C2B9038}"/>
          </ac:spMkLst>
        </pc:spChg>
        <pc:spChg chg="add 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36" creationId="{69833FDA-D734-F95E-9FFE-B37CD0C3EA3E}"/>
          </ac:spMkLst>
        </pc:spChg>
        <pc:spChg chg="mod">
          <ac:chgData name="夏樹 石田" userId="8bec109333bfdc70" providerId="LiveId" clId="{BBCEBCF1-08B6-49D9-95E8-73B63688EAAF}" dt="2025-03-27T12:13:54.271" v="120" actId="408"/>
          <ac:spMkLst>
            <pc:docMk/>
            <pc:sldMk cId="4070247096" sldId="286"/>
            <ac:spMk id="37" creationId="{92EAEC6B-B5E8-5B40-87E7-37517140515A}"/>
          </ac:spMkLst>
        </pc:spChg>
        <pc:spChg chg="add mod">
          <ac:chgData name="夏樹 石田" userId="8bec109333bfdc70" providerId="LiveId" clId="{BBCEBCF1-08B6-49D9-95E8-73B63688EAAF}" dt="2025-03-27T12:13:37.564" v="119" actId="1035"/>
          <ac:spMkLst>
            <pc:docMk/>
            <pc:sldMk cId="4070247096" sldId="286"/>
            <ac:spMk id="38" creationId="{9D942A87-17A1-B3C3-6DDE-02B9D30A8C4A}"/>
          </ac:spMkLst>
        </pc:spChg>
        <pc:spChg chg="add mod">
          <ac:chgData name="夏樹 石田" userId="8bec109333bfdc70" providerId="LiveId" clId="{BBCEBCF1-08B6-49D9-95E8-73B63688EAAF}" dt="2025-03-27T12:13:37.564" v="119" actId="1035"/>
          <ac:spMkLst>
            <pc:docMk/>
            <pc:sldMk cId="4070247096" sldId="286"/>
            <ac:spMk id="40" creationId="{77C1D2A5-BDDF-6D48-4DD9-B794870E89FB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41" creationId="{0355318D-4D87-45AA-0F09-219436AACA04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42" creationId="{EE28E784-BC60-2F4D-2307-50962E755B57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43" creationId="{36FB53D2-E995-7EFC-1F68-513DE562FD34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45" creationId="{B2D1F252-B0B2-9AED-8632-4B68E943A4E1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46" creationId="{8EC4F5FA-3EE1-71D3-29F6-6A64DA4BF958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47" creationId="{0A9DE89C-7812-2B1A-1C10-3BC7084F1BF0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48" creationId="{B28666F2-953A-871E-814E-7CF7ADAD497A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49" creationId="{467FB6D6-E9F3-DB49-F4AA-69D7F163BCF1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50" creationId="{C4B58348-B32B-DB7F-E01E-FA00661B508E}"/>
          </ac:spMkLst>
        </pc:spChg>
        <pc:spChg chg="add mod">
          <ac:chgData name="夏樹 石田" userId="8bec109333bfdc70" providerId="LiveId" clId="{BBCEBCF1-08B6-49D9-95E8-73B63688EAAF}" dt="2025-03-27T12:07:16.982" v="11" actId="1035"/>
          <ac:spMkLst>
            <pc:docMk/>
            <pc:sldMk cId="4070247096" sldId="286"/>
            <ac:spMk id="51" creationId="{FBFE682A-24E1-D32D-19A2-B05A1A651FF5}"/>
          </ac:spMkLst>
        </pc:spChg>
        <pc:spChg chg="mod">
          <ac:chgData name="夏樹 石田" userId="8bec109333bfdc70" providerId="LiveId" clId="{BBCEBCF1-08B6-49D9-95E8-73B63688EAAF}" dt="2025-03-27T12:12:28.514" v="93" actId="408"/>
          <ac:spMkLst>
            <pc:docMk/>
            <pc:sldMk cId="4070247096" sldId="286"/>
            <ac:spMk id="52" creationId="{42A2656E-5F57-2E6E-2084-F8FF7BC25727}"/>
          </ac:spMkLst>
        </pc:spChg>
        <pc:spChg chg="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53" creationId="{30C8E201-959B-D0AA-5001-ECD253F82F42}"/>
          </ac:spMkLst>
        </pc:spChg>
        <pc:spChg chg="add 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54" creationId="{AD2A0A1E-3408-B17F-7C5B-D53141C9B187}"/>
          </ac:spMkLst>
        </pc:spChg>
        <pc:spChg chg="add 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55" creationId="{FABFFA85-5516-81E0-1ADB-5C01A19DAF7C}"/>
          </ac:spMkLst>
        </pc:spChg>
        <pc:spChg chg="mod">
          <ac:chgData name="夏樹 石田" userId="8bec109333bfdc70" providerId="LiveId" clId="{BBCEBCF1-08B6-49D9-95E8-73B63688EAAF}" dt="2025-03-27T12:12:28.514" v="93" actId="408"/>
          <ac:spMkLst>
            <pc:docMk/>
            <pc:sldMk cId="4070247096" sldId="286"/>
            <ac:spMk id="56" creationId="{B804E1DC-9AB1-0FB9-B409-29F2CA9EC277}"/>
          </ac:spMkLst>
        </pc:spChg>
        <pc:spChg chg="add 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58" creationId="{1928F0EB-FDEA-CC56-E4D7-CE5722720D03}"/>
          </ac:spMkLst>
        </pc:spChg>
        <pc:spChg chg="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59" creationId="{8EF90E2F-0674-D823-783B-11A38136B58E}"/>
          </ac:spMkLst>
        </pc:spChg>
        <pc:spChg chg="add 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60" creationId="{151CF53E-0F47-8F86-B24C-8D79F7EAAECD}"/>
          </ac:spMkLst>
        </pc:spChg>
        <pc:spChg chg="mod">
          <ac:chgData name="夏樹 石田" userId="8bec109333bfdc70" providerId="LiveId" clId="{BBCEBCF1-08B6-49D9-95E8-73B63688EAAF}" dt="2025-03-27T12:12:28.514" v="93" actId="408"/>
          <ac:spMkLst>
            <pc:docMk/>
            <pc:sldMk cId="4070247096" sldId="286"/>
            <ac:spMk id="61" creationId="{3413C61D-528C-C3A2-199E-5072BD990128}"/>
          </ac:spMkLst>
        </pc:spChg>
        <pc:spChg chg="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62" creationId="{2E3ED0FA-03DF-54B8-890C-14F53096E402}"/>
          </ac:spMkLst>
        </pc:spChg>
        <pc:spChg chg="mod">
          <ac:chgData name="夏樹 石田" userId="8bec109333bfdc70" providerId="LiveId" clId="{BBCEBCF1-08B6-49D9-95E8-73B63688EAAF}" dt="2025-03-27T12:12:28.514" v="93" actId="408"/>
          <ac:spMkLst>
            <pc:docMk/>
            <pc:sldMk cId="4070247096" sldId="286"/>
            <ac:spMk id="63" creationId="{0D5EA673-C685-62E4-C4A3-295D7A6C809C}"/>
          </ac:spMkLst>
        </pc:spChg>
        <pc:spChg chg="add 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128" creationId="{2B97B221-5EDD-1EE4-33C4-E8DFAA057B1D}"/>
          </ac:spMkLst>
        </pc:spChg>
        <pc:spChg chg="mod">
          <ac:chgData name="夏樹 石田" userId="8bec109333bfdc70" providerId="LiveId" clId="{BBCEBCF1-08B6-49D9-95E8-73B63688EAAF}" dt="2025-03-27T12:11:21.574" v="91" actId="1037"/>
          <ac:spMkLst>
            <pc:docMk/>
            <pc:sldMk cId="4070247096" sldId="286"/>
            <ac:spMk id="129" creationId="{25320389-F2C6-7FCB-7A56-E64E7AB8783B}"/>
          </ac:spMkLst>
        </pc:spChg>
        <pc:spChg chg="add 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130" creationId="{5D8B8906-BD66-DCE5-1BDC-42F1AC7BFE1E}"/>
          </ac:spMkLst>
        </pc:spChg>
        <pc:spChg chg="add mod">
          <ac:chgData name="夏樹 石田" userId="8bec109333bfdc70" providerId="LiveId" clId="{BBCEBCF1-08B6-49D9-95E8-73B63688EAAF}" dt="2025-03-27T12:13:04.899" v="94" actId="555"/>
          <ac:spMkLst>
            <pc:docMk/>
            <pc:sldMk cId="4070247096" sldId="286"/>
            <ac:spMk id="131" creationId="{C9502BF6-B4E9-0582-E6E5-089583CE284A}"/>
          </ac:spMkLst>
        </pc:spChg>
        <pc:spChg chg="add mod">
          <ac:chgData name="夏樹 石田" userId="8bec109333bfdc70" providerId="LiveId" clId="{BBCEBCF1-08B6-49D9-95E8-73B63688EAAF}" dt="2025-03-27T12:08:54.835" v="15" actId="1076"/>
          <ac:spMkLst>
            <pc:docMk/>
            <pc:sldMk cId="4070247096" sldId="286"/>
            <ac:spMk id="134" creationId="{D6966874-8573-9A77-4B8F-74D6DCE79A2E}"/>
          </ac:spMkLst>
        </pc:spChg>
        <pc:spChg chg="add mod">
          <ac:chgData name="夏樹 石田" userId="8bec109333bfdc70" providerId="LiveId" clId="{BBCEBCF1-08B6-49D9-95E8-73B63688EAAF}" dt="2025-03-27T12:08:54.835" v="15" actId="1076"/>
          <ac:spMkLst>
            <pc:docMk/>
            <pc:sldMk cId="4070247096" sldId="286"/>
            <ac:spMk id="140" creationId="{1E050A6F-9951-E436-35BC-D543B3214A2C}"/>
          </ac:spMkLst>
        </pc:spChg>
        <pc:spChg chg="add mod">
          <ac:chgData name="夏樹 石田" userId="8bec109333bfdc70" providerId="LiveId" clId="{BBCEBCF1-08B6-49D9-95E8-73B63688EAAF}" dt="2025-03-27T12:08:54.835" v="15" actId="1076"/>
          <ac:spMkLst>
            <pc:docMk/>
            <pc:sldMk cId="4070247096" sldId="286"/>
            <ac:spMk id="141" creationId="{259E7EAE-4962-51DC-48D2-4DFA05CF8DB7}"/>
          </ac:spMkLst>
        </pc:spChg>
        <pc:spChg chg="add mod">
          <ac:chgData name="夏樹 石田" userId="8bec109333bfdc70" providerId="LiveId" clId="{BBCEBCF1-08B6-49D9-95E8-73B63688EAAF}" dt="2025-03-27T12:10:14.477" v="33" actId="1076"/>
          <ac:spMkLst>
            <pc:docMk/>
            <pc:sldMk cId="4070247096" sldId="286"/>
            <ac:spMk id="142" creationId="{1A69A18D-06F3-7739-610F-37A71677D364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43" creationId="{2778CD03-992C-7304-E1E5-17AC30457E62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44" creationId="{1C1368B4-ED47-8CD8-075F-298B201D6509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45" creationId="{2598E7DD-E254-0276-8EA8-4D09D4DCFD22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46" creationId="{0FFA66AF-8D15-DA05-8A8F-3E920B2D6D90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47" creationId="{488E3AF0-82DE-D890-962F-ED7A2CCD7999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48" creationId="{C8140F49-5A6B-51E5-694E-F4AD610F2CD7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50" creationId="{81B7D5EB-25B1-30D1-96A0-0C6F9376EFE6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51" creationId="{21764590-30D6-98F6-3469-7ECAC9290BC0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52" creationId="{974BFD07-66F6-7229-1705-7A3599699B51}"/>
          </ac:spMkLst>
        </pc:spChg>
        <pc:spChg chg="add mod">
          <ac:chgData name="夏樹 石田" userId="8bec109333bfdc70" providerId="LiveId" clId="{BBCEBCF1-08B6-49D9-95E8-73B63688EAAF}" dt="2025-03-27T12:14:29.609" v="122" actId="1076"/>
          <ac:spMkLst>
            <pc:docMk/>
            <pc:sldMk cId="4070247096" sldId="286"/>
            <ac:spMk id="153" creationId="{9E40AFB7-E12A-FB4A-97F7-CEC519F0DA4F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54" creationId="{F52BE4F1-C036-8CFE-F997-9FA90E301DB3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55" creationId="{57EFD2D1-E125-BD88-40B9-61B86E17DFD6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56" creationId="{6B4573A9-8E4D-B686-8D7B-407C840CBA58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57" creationId="{86158121-5124-14CB-7F98-C3DF5B563425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58" creationId="{71CA3376-5C25-AF90-D111-CE49B1E571BC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59" creationId="{FBE17BEF-BDDE-6B11-8F47-A51687E76A67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61" creationId="{50F16429-3E1A-F9E4-6D88-D16FC53CD321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62" creationId="{0039C161-CBDD-F708-BF9F-3D7C043C0A3F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63" creationId="{71BAB0AC-20C4-B796-0113-61053EF8B906}"/>
          </ac:spMkLst>
        </pc:spChg>
        <pc:spChg chg="add mod">
          <ac:chgData name="夏樹 石田" userId="8bec109333bfdc70" providerId="LiveId" clId="{BBCEBCF1-08B6-49D9-95E8-73B63688EAAF}" dt="2025-03-27T12:14:36.611" v="124" actId="1076"/>
          <ac:spMkLst>
            <pc:docMk/>
            <pc:sldMk cId="4070247096" sldId="286"/>
            <ac:spMk id="164" creationId="{B6EBB5B0-5475-205F-822A-C71C40AA939D}"/>
          </ac:spMkLst>
        </pc:spChg>
        <pc:spChg chg="del">
          <ac:chgData name="夏樹 石田" userId="8bec109333bfdc70" providerId="LiveId" clId="{BBCEBCF1-08B6-49D9-95E8-73B63688EAAF}" dt="2025-03-27T12:15:56.062" v="132" actId="478"/>
          <ac:spMkLst>
            <pc:docMk/>
            <pc:sldMk cId="4070247096" sldId="286"/>
            <ac:spMk id="165" creationId="{DE914BF9-74A1-E7D1-9199-A27935CA8A25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66" creationId="{AC2514A5-C61B-4248-987C-04D3C0EB542A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68" creationId="{AD283A5C-C72D-30D2-0BE2-1E3D3C2EB1AF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70" creationId="{8223BA0C-05A6-047C-9E96-D67EDDFE4938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71" creationId="{148E54D9-424F-FF56-EEA0-8B6D8AF29DD6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72" creationId="{070909AF-15A4-5DA0-530E-34E35268EBEA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74" creationId="{450F959D-D0BF-5FFE-86A8-151C6DCA92FD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75" creationId="{66B1ACF1-E788-2AF6-84F3-B132ED7776B9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76" creationId="{55325DF8-21F7-FA79-2F7D-925FAB7D7E9A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77" creationId="{365536E4-8FA7-C27D-4D27-0B9628D0913C}"/>
          </ac:spMkLst>
        </pc:spChg>
        <pc:spChg chg="add mod">
          <ac:chgData name="夏樹 石田" userId="8bec109333bfdc70" providerId="LiveId" clId="{BBCEBCF1-08B6-49D9-95E8-73B63688EAAF}" dt="2025-03-27T12:15:00.352" v="126" actId="1076"/>
          <ac:spMkLst>
            <pc:docMk/>
            <pc:sldMk cId="4070247096" sldId="286"/>
            <ac:spMk id="182" creationId="{76833841-2BF9-B0D9-2465-C090DAF9CFA6}"/>
          </ac:spMkLst>
        </pc:spChg>
        <pc:spChg chg="del">
          <ac:chgData name="夏樹 石田" userId="8bec109333bfdc70" providerId="LiveId" clId="{BBCEBCF1-08B6-49D9-95E8-73B63688EAAF}" dt="2025-03-27T12:15:31.718" v="129" actId="478"/>
          <ac:spMkLst>
            <pc:docMk/>
            <pc:sldMk cId="4070247096" sldId="286"/>
            <ac:spMk id="183" creationId="{7BFFAA6C-E846-C9A8-6C49-72FBEFB98D35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84" creationId="{1A95B948-0183-7B60-A74D-B87C02636F87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85" creationId="{0B770CC7-F689-6592-3E7C-E600BDF4BF16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86" creationId="{C5EEFA97-C60A-8308-6E69-87ABD0D9F59F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87" creationId="{FD929C66-6E79-84A7-B3FE-230E5A557482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88" creationId="{88229275-8A3A-EBA0-AD99-B4BF4CB2EC82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91" creationId="{0EAAC17C-67DD-D6B3-ADC4-F9F17F52037B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95" creationId="{700C01E7-08A8-D666-4B62-F52B5823AFE7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96" creationId="{2CBC9C29-0C38-0DF5-BD4A-288C06BF44D5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97" creationId="{CC89F58A-1D22-4A98-2B05-C36A44A9EE93}"/>
          </ac:spMkLst>
        </pc:spChg>
        <pc:spChg chg="add mod">
          <ac:chgData name="夏樹 石田" userId="8bec109333bfdc70" providerId="LiveId" clId="{BBCEBCF1-08B6-49D9-95E8-73B63688EAAF}" dt="2025-03-27T12:15:25.895" v="128" actId="1076"/>
          <ac:spMkLst>
            <pc:docMk/>
            <pc:sldMk cId="4070247096" sldId="286"/>
            <ac:spMk id="199" creationId="{832BBDBA-8663-1515-5574-31CFD969B285}"/>
          </ac:spMkLst>
        </pc:spChg>
        <pc:picChg chg="mod modCrop">
          <ac:chgData name="夏樹 石田" userId="8bec109333bfdc70" providerId="LiveId" clId="{BBCEBCF1-08B6-49D9-95E8-73B63688EAAF}" dt="2025-03-27T12:07:25.350" v="12" actId="732"/>
          <ac:picMkLst>
            <pc:docMk/>
            <pc:sldMk cId="4070247096" sldId="286"/>
            <ac:picMk id="3" creationId="{76091B29-A869-E0F9-9EEB-3B87BAA831BF}"/>
          </ac:picMkLst>
        </pc:picChg>
        <pc:picChg chg="mod modCrop">
          <ac:chgData name="夏樹 石田" userId="8bec109333bfdc70" providerId="LiveId" clId="{BBCEBCF1-08B6-49D9-95E8-73B63688EAAF}" dt="2025-03-27T12:15:49.052" v="131" actId="732"/>
          <ac:picMkLst>
            <pc:docMk/>
            <pc:sldMk cId="4070247096" sldId="286"/>
            <ac:picMk id="4" creationId="{BEF0E976-3A01-AD9B-F9BD-881E06A49017}"/>
          </ac:picMkLst>
        </pc:picChg>
        <pc:picChg chg="del">
          <ac:chgData name="夏樹 石田" userId="8bec109333bfdc70" providerId="LiveId" clId="{BBCEBCF1-08B6-49D9-95E8-73B63688EAAF}" dt="2025-03-27T12:04:33.784" v="0" actId="478"/>
          <ac:picMkLst>
            <pc:docMk/>
            <pc:sldMk cId="4070247096" sldId="286"/>
            <ac:picMk id="16" creationId="{8848D926-AD11-E854-6C9E-C6D311644537}"/>
          </ac:picMkLst>
        </pc:picChg>
        <pc:picChg chg="mod modCrop">
          <ac:chgData name="夏樹 石田" userId="8bec109333bfdc70" providerId="LiveId" clId="{BBCEBCF1-08B6-49D9-95E8-73B63688EAAF}" dt="2025-03-27T12:10:26.848" v="35" actId="732"/>
          <ac:picMkLst>
            <pc:docMk/>
            <pc:sldMk cId="4070247096" sldId="286"/>
            <ac:picMk id="19" creationId="{776D6192-C312-1322-2AB3-EA12B49964BB}"/>
          </ac:picMkLst>
        </pc:picChg>
        <pc:picChg chg="mod modCrop">
          <ac:chgData name="夏樹 石田" userId="8bec109333bfdc70" providerId="LiveId" clId="{BBCEBCF1-08B6-49D9-95E8-73B63688EAAF}" dt="2025-03-27T12:16:05.374" v="133" actId="732"/>
          <ac:picMkLst>
            <pc:docMk/>
            <pc:sldMk cId="4070247096" sldId="286"/>
            <ac:picMk id="20" creationId="{05564FAD-33E8-E6B3-C5E4-D3D32B892C16}"/>
          </ac:picMkLst>
        </pc:picChg>
      </pc:sldChg>
    </pc:docChg>
  </pc:docChgLst>
  <pc:docChgLst>
    <pc:chgData name="夏樹 石田" userId="8bec109333bfdc70" providerId="LiveId" clId="{F9A43B8A-272F-4ABD-AA55-51815A16FF42}"/>
    <pc:docChg chg="undo custSel delSld modSld">
      <pc:chgData name="夏樹 石田" userId="8bec109333bfdc70" providerId="LiveId" clId="{F9A43B8A-272F-4ABD-AA55-51815A16FF42}" dt="2024-02-17T05:44:51.894" v="561" actId="14100"/>
      <pc:docMkLst>
        <pc:docMk/>
      </pc:docMkLst>
      <pc:sldChg chg="del">
        <pc:chgData name="夏樹 石田" userId="8bec109333bfdc70" providerId="LiveId" clId="{F9A43B8A-272F-4ABD-AA55-51815A16FF42}" dt="2024-02-17T02:30:22.017" v="0" actId="47"/>
        <pc:sldMkLst>
          <pc:docMk/>
          <pc:sldMk cId="377763989" sldId="269"/>
        </pc:sldMkLst>
      </pc:sldChg>
      <pc:sldChg chg="del">
        <pc:chgData name="夏樹 石田" userId="8bec109333bfdc70" providerId="LiveId" clId="{F9A43B8A-272F-4ABD-AA55-51815A16FF42}" dt="2024-02-17T02:30:23.179" v="1" actId="47"/>
        <pc:sldMkLst>
          <pc:docMk/>
          <pc:sldMk cId="2172588776" sldId="285"/>
        </pc:sldMkLst>
      </pc:sldChg>
      <pc:sldChg chg="addSp delSp modSp mod">
        <pc:chgData name="夏樹 石田" userId="8bec109333bfdc70" providerId="LiveId" clId="{F9A43B8A-272F-4ABD-AA55-51815A16FF42}" dt="2024-02-17T05:44:51.894" v="561" actId="14100"/>
        <pc:sldMkLst>
          <pc:docMk/>
          <pc:sldMk cId="4070247096" sldId="286"/>
        </pc:sldMkLst>
      </pc:sldChg>
    </pc:docChg>
  </pc:docChgLst>
  <pc:docChgLst>
    <pc:chgData name="夏樹 石田" userId="8bec109333bfdc70" providerId="LiveId" clId="{F0A42EAC-6C58-43A4-8CB4-0558A32BB2F8}"/>
    <pc:docChg chg="undo custSel modSld">
      <pc:chgData name="夏樹 石田" userId="8bec109333bfdc70" providerId="LiveId" clId="{F0A42EAC-6C58-43A4-8CB4-0558A32BB2F8}" dt="2023-10-21T09:42:11.598" v="4" actId="207"/>
      <pc:docMkLst>
        <pc:docMk/>
      </pc:docMkLst>
      <pc:sldChg chg="modSp mod">
        <pc:chgData name="夏樹 石田" userId="8bec109333bfdc70" providerId="LiveId" clId="{F0A42EAC-6C58-43A4-8CB4-0558A32BB2F8}" dt="2023-10-21T09:42:11.598" v="4" actId="207"/>
        <pc:sldMkLst>
          <pc:docMk/>
          <pc:sldMk cId="377763989" sldId="26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6B8368-64E1-4E15-8E80-64919237BAF3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580F20-A2BF-4325-86D9-4469FF28B4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979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7952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452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221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5071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51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19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875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8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630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99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4641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B76BF-0690-4E2F-B59D-BD84856B5201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C79D5A-A706-4199-8740-D6DFACBDDD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096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8" Type="http://schemas.openxmlformats.org/officeDocument/2006/relationships/image" Target="../media/image7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A0F79293-588E-2290-5FAE-32898D410490}"/>
              </a:ext>
            </a:extLst>
          </p:cNvPr>
          <p:cNvSpPr/>
          <p:nvPr/>
        </p:nvSpPr>
        <p:spPr>
          <a:xfrm>
            <a:off x="274487" y="494924"/>
            <a:ext cx="6227832" cy="4466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F6FB60B0-CEAA-96AA-D02C-D2ED2F8EA6C3}"/>
              </a:ext>
            </a:extLst>
          </p:cNvPr>
          <p:cNvSpPr txBox="1"/>
          <p:nvPr/>
        </p:nvSpPr>
        <p:spPr>
          <a:xfrm>
            <a:off x="274487" y="123114"/>
            <a:ext cx="6309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DCDD0FD-C509-57BF-4E75-5551B099647B}"/>
              </a:ext>
            </a:extLst>
          </p:cNvPr>
          <p:cNvSpPr txBox="1"/>
          <p:nvPr/>
        </p:nvSpPr>
        <p:spPr>
          <a:xfrm>
            <a:off x="430733" y="672723"/>
            <a:ext cx="345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ADEC2B4-54C3-1490-58A1-A47F480284B9}"/>
              </a:ext>
            </a:extLst>
          </p:cNvPr>
          <p:cNvSpPr txBox="1"/>
          <p:nvPr/>
        </p:nvSpPr>
        <p:spPr>
          <a:xfrm>
            <a:off x="3480188" y="672723"/>
            <a:ext cx="345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6091B29-A869-E0F9-9EEB-3B87BAA831B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086" b="27351"/>
          <a:stretch/>
        </p:blipFill>
        <p:spPr>
          <a:xfrm>
            <a:off x="772235" y="980632"/>
            <a:ext cx="2467775" cy="1178993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EF0E976-3A01-AD9B-F9BD-881E06A4901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884" b="25757"/>
          <a:stretch/>
        </p:blipFill>
        <p:spPr>
          <a:xfrm>
            <a:off x="3921210" y="991203"/>
            <a:ext cx="2446117" cy="121078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086791F-FA70-AD02-971B-F48469C426BE}"/>
              </a:ext>
            </a:extLst>
          </p:cNvPr>
          <p:cNvSpPr txBox="1"/>
          <p:nvPr/>
        </p:nvSpPr>
        <p:spPr>
          <a:xfrm rot="16200000">
            <a:off x="-34916" y="1651358"/>
            <a:ext cx="11789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26BE959-C07A-E9A7-896E-C510007D1CD7}"/>
              </a:ext>
            </a:extLst>
          </p:cNvPr>
          <p:cNvSpPr txBox="1"/>
          <p:nvPr/>
        </p:nvSpPr>
        <p:spPr>
          <a:xfrm>
            <a:off x="4046697" y="2528007"/>
            <a:ext cx="17856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 disease duration groups (FC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17F4476-8A87-0A5C-75CF-6BF172567514}"/>
              </a:ext>
            </a:extLst>
          </p:cNvPr>
          <p:cNvSpPr txBox="1"/>
          <p:nvPr/>
        </p:nvSpPr>
        <p:spPr>
          <a:xfrm rot="16200000">
            <a:off x="3167480" y="1663886"/>
            <a:ext cx="112677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B1C0213-137C-05FB-B4DA-E4A9E7C49559}"/>
              </a:ext>
            </a:extLst>
          </p:cNvPr>
          <p:cNvSpPr txBox="1"/>
          <p:nvPr/>
        </p:nvSpPr>
        <p:spPr>
          <a:xfrm>
            <a:off x="1025677" y="2503472"/>
            <a:ext cx="17142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rt disease duration groups (FC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9C8442A1-1180-3873-30E4-1B09DB430811}"/>
              </a:ext>
            </a:extLst>
          </p:cNvPr>
          <p:cNvCxnSpPr>
            <a:cxnSpLocks/>
          </p:cNvCxnSpPr>
          <p:nvPr/>
        </p:nvCxnSpPr>
        <p:spPr>
          <a:xfrm>
            <a:off x="804472" y="1586497"/>
            <a:ext cx="235799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EA50F0CB-568D-705B-916F-EF6696FBD76F}"/>
              </a:ext>
            </a:extLst>
          </p:cNvPr>
          <p:cNvCxnSpPr>
            <a:cxnSpLocks/>
          </p:cNvCxnSpPr>
          <p:nvPr/>
        </p:nvCxnSpPr>
        <p:spPr>
          <a:xfrm>
            <a:off x="3936164" y="1603983"/>
            <a:ext cx="238266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図 18">
            <a:extLst>
              <a:ext uri="{FF2B5EF4-FFF2-40B4-BE49-F238E27FC236}">
                <a16:creationId xmlns:a16="http://schemas.microsoft.com/office/drawing/2014/main" id="{776D6192-C312-1322-2AB3-EA12B49964B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9236" b="26024"/>
          <a:stretch/>
        </p:blipFill>
        <p:spPr>
          <a:xfrm>
            <a:off x="803271" y="3229430"/>
            <a:ext cx="2403630" cy="1200527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05564FAD-33E8-E6B3-C5E4-D3D32B892C16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9236" b="25329"/>
          <a:stretch/>
        </p:blipFill>
        <p:spPr>
          <a:xfrm>
            <a:off x="3915194" y="3215395"/>
            <a:ext cx="2403630" cy="1210785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12102A7-BD80-ABF8-37A4-6A2B3F51CFF7}"/>
              </a:ext>
            </a:extLst>
          </p:cNvPr>
          <p:cNvSpPr txBox="1"/>
          <p:nvPr/>
        </p:nvSpPr>
        <p:spPr>
          <a:xfrm>
            <a:off x="430733" y="2949805"/>
            <a:ext cx="345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B0FC6A7-C7C7-AA50-5F74-788916B53570}"/>
              </a:ext>
            </a:extLst>
          </p:cNvPr>
          <p:cNvSpPr txBox="1"/>
          <p:nvPr/>
        </p:nvSpPr>
        <p:spPr>
          <a:xfrm>
            <a:off x="3510195" y="2949805"/>
            <a:ext cx="345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CA2328BB-D2A8-D94A-C78E-01C7EE1F1474}"/>
              </a:ext>
            </a:extLst>
          </p:cNvPr>
          <p:cNvCxnSpPr>
            <a:cxnSpLocks/>
          </p:cNvCxnSpPr>
          <p:nvPr/>
        </p:nvCxnSpPr>
        <p:spPr>
          <a:xfrm>
            <a:off x="830189" y="4029012"/>
            <a:ext cx="2293059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9CFFCA29-EA32-EDDB-F91F-305FD1BE36BA}"/>
              </a:ext>
            </a:extLst>
          </p:cNvPr>
          <p:cNvCxnSpPr>
            <a:cxnSpLocks/>
          </p:cNvCxnSpPr>
          <p:nvPr/>
        </p:nvCxnSpPr>
        <p:spPr>
          <a:xfrm>
            <a:off x="3940122" y="4029955"/>
            <a:ext cx="2293059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E5CE027-DFD9-2BE2-7157-80EAAE4C64D4}"/>
              </a:ext>
            </a:extLst>
          </p:cNvPr>
          <p:cNvSpPr txBox="1"/>
          <p:nvPr/>
        </p:nvSpPr>
        <p:spPr>
          <a:xfrm>
            <a:off x="1019040" y="4794401"/>
            <a:ext cx="17142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rt disease duration groups (CRP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9660654-379B-9C69-2E41-1F8D735255E1}"/>
              </a:ext>
            </a:extLst>
          </p:cNvPr>
          <p:cNvSpPr txBox="1"/>
          <p:nvPr/>
        </p:nvSpPr>
        <p:spPr>
          <a:xfrm>
            <a:off x="4078016" y="4777773"/>
            <a:ext cx="17856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 disease duration groups (CRP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293B9D7-8E22-9A2E-D433-E2276BDE70AE}"/>
              </a:ext>
            </a:extLst>
          </p:cNvPr>
          <p:cNvSpPr txBox="1"/>
          <p:nvPr/>
        </p:nvSpPr>
        <p:spPr>
          <a:xfrm rot="16200000">
            <a:off x="3161130" y="3956236"/>
            <a:ext cx="112677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337B87A-5958-8E6A-3A33-5A0D5069942F}"/>
              </a:ext>
            </a:extLst>
          </p:cNvPr>
          <p:cNvSpPr txBox="1"/>
          <p:nvPr/>
        </p:nvSpPr>
        <p:spPr>
          <a:xfrm rot="16200000">
            <a:off x="-28566" y="3956408"/>
            <a:ext cx="11789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E3D1BCE-4A5F-CE89-5921-08B797A43DB4}"/>
              </a:ext>
            </a:extLst>
          </p:cNvPr>
          <p:cNvSpPr txBox="1"/>
          <p:nvPr/>
        </p:nvSpPr>
        <p:spPr>
          <a:xfrm rot="18966945">
            <a:off x="2492100" y="2214316"/>
            <a:ext cx="6190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30 yrs (n=101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DCC1872-36CA-622B-1667-A39EA8AB305A}"/>
              </a:ext>
            </a:extLst>
          </p:cNvPr>
          <p:cNvSpPr txBox="1"/>
          <p:nvPr/>
        </p:nvSpPr>
        <p:spPr>
          <a:xfrm rot="18966945">
            <a:off x="2204415" y="2225428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20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5AEC910-7ED2-94FD-E0CD-8D7B716B2BE0}"/>
              </a:ext>
            </a:extLst>
          </p:cNvPr>
          <p:cNvSpPr txBox="1"/>
          <p:nvPr/>
        </p:nvSpPr>
        <p:spPr>
          <a:xfrm rot="18966945">
            <a:off x="2043057" y="2225428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5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A2B3BDB-8C88-0288-7F18-BD69828A66B8}"/>
              </a:ext>
            </a:extLst>
          </p:cNvPr>
          <p:cNvSpPr txBox="1"/>
          <p:nvPr/>
        </p:nvSpPr>
        <p:spPr>
          <a:xfrm rot="18966945">
            <a:off x="1881699" y="2225428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4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33CA96D-13B3-565F-0CDE-1EFBFA9FB145}"/>
              </a:ext>
            </a:extLst>
          </p:cNvPr>
          <p:cNvSpPr txBox="1"/>
          <p:nvPr/>
        </p:nvSpPr>
        <p:spPr>
          <a:xfrm rot="18966945">
            <a:off x="1720341" y="2225428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3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A96D522-9CF8-F7A5-404C-54CD1949DBFE}"/>
              </a:ext>
            </a:extLst>
          </p:cNvPr>
          <p:cNvSpPr txBox="1"/>
          <p:nvPr/>
        </p:nvSpPr>
        <p:spPr>
          <a:xfrm rot="18966945">
            <a:off x="1558983" y="2225428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2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1C91B18F-BBC2-7CAA-BA25-D0D260BAA391}"/>
              </a:ext>
            </a:extLst>
          </p:cNvPr>
          <p:cNvSpPr txBox="1"/>
          <p:nvPr/>
        </p:nvSpPr>
        <p:spPr>
          <a:xfrm rot="18966945">
            <a:off x="1397625" y="2225428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1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E5F959F-3ACB-5BC4-AABC-BF8E8F923ABF}"/>
              </a:ext>
            </a:extLst>
          </p:cNvPr>
          <p:cNvSpPr txBox="1"/>
          <p:nvPr/>
        </p:nvSpPr>
        <p:spPr>
          <a:xfrm rot="18966945">
            <a:off x="1236267" y="2225428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0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21AD6D7-74C9-E493-D97F-3E77BB61C4A5}"/>
              </a:ext>
            </a:extLst>
          </p:cNvPr>
          <p:cNvSpPr txBox="1"/>
          <p:nvPr/>
        </p:nvSpPr>
        <p:spPr>
          <a:xfrm rot="18966945">
            <a:off x="1106969" y="2236540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9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B8E3E38-4512-C712-E098-7A7F989C9864}"/>
              </a:ext>
            </a:extLst>
          </p:cNvPr>
          <p:cNvSpPr txBox="1"/>
          <p:nvPr/>
        </p:nvSpPr>
        <p:spPr>
          <a:xfrm rot="18966945">
            <a:off x="977671" y="2236540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8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C7E063E-7E85-121D-35B7-B8859C2B9038}"/>
              </a:ext>
            </a:extLst>
          </p:cNvPr>
          <p:cNvSpPr txBox="1"/>
          <p:nvPr/>
        </p:nvSpPr>
        <p:spPr>
          <a:xfrm rot="18966945">
            <a:off x="848373" y="2236540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7 yrs (n=47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9833FDA-D734-F95E-9FFE-B37CD0C3EA3E}"/>
              </a:ext>
            </a:extLst>
          </p:cNvPr>
          <p:cNvSpPr txBox="1"/>
          <p:nvPr/>
        </p:nvSpPr>
        <p:spPr>
          <a:xfrm rot="18966945">
            <a:off x="719075" y="2236540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6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2EAEC6B-B5E8-5B40-87E7-37517140515A}"/>
              </a:ext>
            </a:extLst>
          </p:cNvPr>
          <p:cNvSpPr txBox="1"/>
          <p:nvPr/>
        </p:nvSpPr>
        <p:spPr>
          <a:xfrm rot="18966945">
            <a:off x="589777" y="2236540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5 yrs (n=40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D942A87-17A1-B3C3-6DDE-02B9D30A8C4A}"/>
              </a:ext>
            </a:extLst>
          </p:cNvPr>
          <p:cNvSpPr txBox="1"/>
          <p:nvPr/>
        </p:nvSpPr>
        <p:spPr>
          <a:xfrm rot="18966945">
            <a:off x="460479" y="2236540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4 yrs (n=30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23B0086-9B05-B47E-80FB-F56D12873DE5}"/>
              </a:ext>
            </a:extLst>
          </p:cNvPr>
          <p:cNvSpPr txBox="1"/>
          <p:nvPr/>
        </p:nvSpPr>
        <p:spPr>
          <a:xfrm rot="18966945">
            <a:off x="2365776" y="2225428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2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7C1D2A5-BDDF-6D48-4DD9-B794870E89FB}"/>
              </a:ext>
            </a:extLst>
          </p:cNvPr>
          <p:cNvSpPr txBox="1"/>
          <p:nvPr/>
        </p:nvSpPr>
        <p:spPr>
          <a:xfrm rot="18966945">
            <a:off x="2638477" y="2214316"/>
            <a:ext cx="6190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35 yrs (n=110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355318D-4D87-45AA-0F09-219436AACA04}"/>
              </a:ext>
            </a:extLst>
          </p:cNvPr>
          <p:cNvSpPr txBox="1"/>
          <p:nvPr/>
        </p:nvSpPr>
        <p:spPr>
          <a:xfrm>
            <a:off x="623145" y="959468"/>
            <a:ext cx="180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E28E784-BC60-2F4D-2307-50962E755B57}"/>
              </a:ext>
            </a:extLst>
          </p:cNvPr>
          <p:cNvSpPr txBox="1"/>
          <p:nvPr/>
        </p:nvSpPr>
        <p:spPr>
          <a:xfrm>
            <a:off x="532832" y="1075848"/>
            <a:ext cx="30241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6FB53D2-E995-7EFC-1F68-513DE562FD34}"/>
              </a:ext>
            </a:extLst>
          </p:cNvPr>
          <p:cNvSpPr txBox="1"/>
          <p:nvPr/>
        </p:nvSpPr>
        <p:spPr>
          <a:xfrm>
            <a:off x="565938" y="1183515"/>
            <a:ext cx="27278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4E98CAE-EC20-C79F-D2EE-05E74FC21155}"/>
              </a:ext>
            </a:extLst>
          </p:cNvPr>
          <p:cNvSpPr txBox="1"/>
          <p:nvPr/>
        </p:nvSpPr>
        <p:spPr>
          <a:xfrm>
            <a:off x="554052" y="1402630"/>
            <a:ext cx="28430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2D1F252-B0B2-9AED-8632-4B68E943A4E1}"/>
              </a:ext>
            </a:extLst>
          </p:cNvPr>
          <p:cNvSpPr txBox="1"/>
          <p:nvPr/>
        </p:nvSpPr>
        <p:spPr>
          <a:xfrm>
            <a:off x="533560" y="1625095"/>
            <a:ext cx="3048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EC4F5FA-3EE1-71D3-29F6-6A64DA4BF958}"/>
              </a:ext>
            </a:extLst>
          </p:cNvPr>
          <p:cNvSpPr txBox="1"/>
          <p:nvPr/>
        </p:nvSpPr>
        <p:spPr>
          <a:xfrm>
            <a:off x="544125" y="1846051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A9DE89C-7812-2B1A-1C10-3BC7084F1BF0}"/>
              </a:ext>
            </a:extLst>
          </p:cNvPr>
          <p:cNvSpPr txBox="1"/>
          <p:nvPr/>
        </p:nvSpPr>
        <p:spPr>
          <a:xfrm>
            <a:off x="562751" y="1291913"/>
            <a:ext cx="2771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28666F2-953A-871E-814E-7CF7ADAD497A}"/>
              </a:ext>
            </a:extLst>
          </p:cNvPr>
          <p:cNvSpPr txBox="1"/>
          <p:nvPr/>
        </p:nvSpPr>
        <p:spPr>
          <a:xfrm>
            <a:off x="562751" y="1517772"/>
            <a:ext cx="2771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467FB6D6-E9F3-DB49-F4AA-69D7F163BCF1}"/>
              </a:ext>
            </a:extLst>
          </p:cNvPr>
          <p:cNvSpPr txBox="1"/>
          <p:nvPr/>
        </p:nvSpPr>
        <p:spPr>
          <a:xfrm>
            <a:off x="545102" y="1737521"/>
            <a:ext cx="29400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4B58348-B32B-DB7F-E01E-FA00661B508E}"/>
              </a:ext>
            </a:extLst>
          </p:cNvPr>
          <p:cNvSpPr txBox="1"/>
          <p:nvPr/>
        </p:nvSpPr>
        <p:spPr>
          <a:xfrm>
            <a:off x="540475" y="1950195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BFE682A-24E1-D32D-19A2-B05A1A651FF5}"/>
              </a:ext>
            </a:extLst>
          </p:cNvPr>
          <p:cNvSpPr txBox="1"/>
          <p:nvPr/>
        </p:nvSpPr>
        <p:spPr>
          <a:xfrm>
            <a:off x="542727" y="2064680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2A2656E-5F57-2E6E-2084-F8FF7BC25727}"/>
              </a:ext>
            </a:extLst>
          </p:cNvPr>
          <p:cNvSpPr txBox="1"/>
          <p:nvPr/>
        </p:nvSpPr>
        <p:spPr>
          <a:xfrm rot="18966945">
            <a:off x="2424820" y="4477909"/>
            <a:ext cx="6190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30 yrs (n=101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0C8E201-959B-D0AA-5001-ECD253F82F42}"/>
              </a:ext>
            </a:extLst>
          </p:cNvPr>
          <p:cNvSpPr txBox="1"/>
          <p:nvPr/>
        </p:nvSpPr>
        <p:spPr>
          <a:xfrm rot="18966945">
            <a:off x="2118176" y="4489021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20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AD2A0A1E-3408-B17F-7C5B-D53141C9B187}"/>
              </a:ext>
            </a:extLst>
          </p:cNvPr>
          <p:cNvSpPr txBox="1"/>
          <p:nvPr/>
        </p:nvSpPr>
        <p:spPr>
          <a:xfrm rot="18966945">
            <a:off x="1964854" y="4489021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5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FABFFA85-5516-81E0-1ADB-5C01A19DAF7C}"/>
              </a:ext>
            </a:extLst>
          </p:cNvPr>
          <p:cNvSpPr txBox="1"/>
          <p:nvPr/>
        </p:nvSpPr>
        <p:spPr>
          <a:xfrm rot="18966945">
            <a:off x="1811532" y="4489021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4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804E1DC-9AB1-0FB9-B409-29F2CA9EC277}"/>
              </a:ext>
            </a:extLst>
          </p:cNvPr>
          <p:cNvSpPr txBox="1"/>
          <p:nvPr/>
        </p:nvSpPr>
        <p:spPr>
          <a:xfrm rot="18966945">
            <a:off x="1658210" y="4489021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3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5AE585F7-1AAA-275B-FF4A-9DE9B6D11C99}"/>
              </a:ext>
            </a:extLst>
          </p:cNvPr>
          <p:cNvSpPr txBox="1"/>
          <p:nvPr/>
        </p:nvSpPr>
        <p:spPr>
          <a:xfrm rot="18966945">
            <a:off x="1504888" y="4489021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2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1928F0EB-FDEA-CC56-E4D7-CE5722720D03}"/>
              </a:ext>
            </a:extLst>
          </p:cNvPr>
          <p:cNvSpPr txBox="1"/>
          <p:nvPr/>
        </p:nvSpPr>
        <p:spPr>
          <a:xfrm rot="18966945">
            <a:off x="1351566" y="4489021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1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8EF90E2F-0674-D823-783B-11A38136B58E}"/>
              </a:ext>
            </a:extLst>
          </p:cNvPr>
          <p:cNvSpPr txBox="1"/>
          <p:nvPr/>
        </p:nvSpPr>
        <p:spPr>
          <a:xfrm rot="18966945">
            <a:off x="1198244" y="4489021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10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51CF53E-0F47-8F86-B24C-8D79F7EAAECD}"/>
              </a:ext>
            </a:extLst>
          </p:cNvPr>
          <p:cNvSpPr txBox="1"/>
          <p:nvPr/>
        </p:nvSpPr>
        <p:spPr>
          <a:xfrm rot="18966945">
            <a:off x="1076982" y="4500133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9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413C61D-528C-C3A2-199E-5072BD990128}"/>
              </a:ext>
            </a:extLst>
          </p:cNvPr>
          <p:cNvSpPr txBox="1"/>
          <p:nvPr/>
        </p:nvSpPr>
        <p:spPr>
          <a:xfrm rot="18966945">
            <a:off x="955720" y="4500133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8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E3ED0FA-03DF-54B8-890C-14F53096E402}"/>
              </a:ext>
            </a:extLst>
          </p:cNvPr>
          <p:cNvSpPr txBox="1"/>
          <p:nvPr/>
        </p:nvSpPr>
        <p:spPr>
          <a:xfrm rot="18966945">
            <a:off x="834458" y="4500133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7 yrs (n=47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0D5EA673-C685-62E4-C4A3-295D7A6C809C}"/>
              </a:ext>
            </a:extLst>
          </p:cNvPr>
          <p:cNvSpPr txBox="1"/>
          <p:nvPr/>
        </p:nvSpPr>
        <p:spPr>
          <a:xfrm rot="18966945">
            <a:off x="713196" y="4500133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6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2B97B221-5EDD-1EE4-33C4-E8DFAA057B1D}"/>
              </a:ext>
            </a:extLst>
          </p:cNvPr>
          <p:cNvSpPr txBox="1"/>
          <p:nvPr/>
        </p:nvSpPr>
        <p:spPr>
          <a:xfrm rot="18966945">
            <a:off x="591934" y="4500133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5 yrs (n=40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25320389-F2C6-7FCB-7A56-E64E7AB8783B}"/>
              </a:ext>
            </a:extLst>
          </p:cNvPr>
          <p:cNvSpPr txBox="1"/>
          <p:nvPr/>
        </p:nvSpPr>
        <p:spPr>
          <a:xfrm rot="18966945">
            <a:off x="470672" y="4500133"/>
            <a:ext cx="55496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4 yrs (n=30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5D8B8906-BD66-DCE5-1BDC-42F1AC7BFE1E}"/>
              </a:ext>
            </a:extLst>
          </p:cNvPr>
          <p:cNvSpPr txBox="1"/>
          <p:nvPr/>
        </p:nvSpPr>
        <p:spPr>
          <a:xfrm rot="18966945">
            <a:off x="2271498" y="4489021"/>
            <a:ext cx="5870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2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rs (n=</a:t>
            </a:r>
            <a:r>
              <a:rPr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C9502BF6-B4E9-0582-E6E5-089583CE284A}"/>
              </a:ext>
            </a:extLst>
          </p:cNvPr>
          <p:cNvSpPr txBox="1"/>
          <p:nvPr/>
        </p:nvSpPr>
        <p:spPr>
          <a:xfrm rot="18966945">
            <a:off x="2610200" y="4477909"/>
            <a:ext cx="6190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35 yrs (n=110)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386CF9B3-8A9C-B83A-2084-E4A13C9DFBC2}"/>
              </a:ext>
            </a:extLst>
          </p:cNvPr>
          <p:cNvSpPr txBox="1"/>
          <p:nvPr/>
        </p:nvSpPr>
        <p:spPr>
          <a:xfrm>
            <a:off x="642217" y="3220103"/>
            <a:ext cx="180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90498166-1F53-C958-44B5-CA2C5671A80B}"/>
              </a:ext>
            </a:extLst>
          </p:cNvPr>
          <p:cNvSpPr txBox="1"/>
          <p:nvPr/>
        </p:nvSpPr>
        <p:spPr>
          <a:xfrm>
            <a:off x="551904" y="3336483"/>
            <a:ext cx="30241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D6966874-8573-9A77-4B8F-74D6DCE79A2E}"/>
              </a:ext>
            </a:extLst>
          </p:cNvPr>
          <p:cNvSpPr txBox="1"/>
          <p:nvPr/>
        </p:nvSpPr>
        <p:spPr>
          <a:xfrm>
            <a:off x="585010" y="3444150"/>
            <a:ext cx="27278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065C1338-1258-03A1-F8FB-44E2AE495C9D}"/>
              </a:ext>
            </a:extLst>
          </p:cNvPr>
          <p:cNvSpPr txBox="1"/>
          <p:nvPr/>
        </p:nvSpPr>
        <p:spPr>
          <a:xfrm>
            <a:off x="573124" y="3663265"/>
            <a:ext cx="28430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D81E43B4-F70E-FD0E-FBBE-06765C5A6614}"/>
              </a:ext>
            </a:extLst>
          </p:cNvPr>
          <p:cNvSpPr txBox="1"/>
          <p:nvPr/>
        </p:nvSpPr>
        <p:spPr>
          <a:xfrm>
            <a:off x="552632" y="3885730"/>
            <a:ext cx="3048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BBA450ED-0699-694C-0E58-66730A4CF35D}"/>
              </a:ext>
            </a:extLst>
          </p:cNvPr>
          <p:cNvSpPr txBox="1"/>
          <p:nvPr/>
        </p:nvSpPr>
        <p:spPr>
          <a:xfrm>
            <a:off x="563197" y="4106686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2AAF05C2-9607-6976-4A0D-62A220599EE6}"/>
              </a:ext>
            </a:extLst>
          </p:cNvPr>
          <p:cNvSpPr txBox="1"/>
          <p:nvPr/>
        </p:nvSpPr>
        <p:spPr>
          <a:xfrm>
            <a:off x="581823" y="3552548"/>
            <a:ext cx="2771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058DD544-24AA-8D36-70BF-D75A2FBB8EFD}"/>
              </a:ext>
            </a:extLst>
          </p:cNvPr>
          <p:cNvSpPr txBox="1"/>
          <p:nvPr/>
        </p:nvSpPr>
        <p:spPr>
          <a:xfrm>
            <a:off x="581823" y="3778407"/>
            <a:ext cx="2771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E050A6F-9951-E436-35BC-D543B3214A2C}"/>
              </a:ext>
            </a:extLst>
          </p:cNvPr>
          <p:cNvSpPr txBox="1"/>
          <p:nvPr/>
        </p:nvSpPr>
        <p:spPr>
          <a:xfrm>
            <a:off x="564174" y="3998156"/>
            <a:ext cx="29400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259E7EAE-4962-51DC-48D2-4DFA05CF8DB7}"/>
              </a:ext>
            </a:extLst>
          </p:cNvPr>
          <p:cNvSpPr txBox="1"/>
          <p:nvPr/>
        </p:nvSpPr>
        <p:spPr>
          <a:xfrm>
            <a:off x="559547" y="4210830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1A69A18D-06F3-7739-610F-37A71677D364}"/>
              </a:ext>
            </a:extLst>
          </p:cNvPr>
          <p:cNvSpPr txBox="1"/>
          <p:nvPr/>
        </p:nvSpPr>
        <p:spPr>
          <a:xfrm>
            <a:off x="568615" y="4313483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2778CD03-992C-7304-E1E5-17AC30457E62}"/>
              </a:ext>
            </a:extLst>
          </p:cNvPr>
          <p:cNvSpPr txBox="1"/>
          <p:nvPr/>
        </p:nvSpPr>
        <p:spPr>
          <a:xfrm>
            <a:off x="3776472" y="981020"/>
            <a:ext cx="180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1C1368B4-ED47-8CD8-075F-298B201D6509}"/>
              </a:ext>
            </a:extLst>
          </p:cNvPr>
          <p:cNvSpPr txBox="1"/>
          <p:nvPr/>
        </p:nvSpPr>
        <p:spPr>
          <a:xfrm>
            <a:off x="3686159" y="1097400"/>
            <a:ext cx="30241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2598E7DD-E254-0276-8EA8-4D09D4DCFD22}"/>
              </a:ext>
            </a:extLst>
          </p:cNvPr>
          <p:cNvSpPr txBox="1"/>
          <p:nvPr/>
        </p:nvSpPr>
        <p:spPr>
          <a:xfrm>
            <a:off x="3719265" y="1205067"/>
            <a:ext cx="27278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0FFA66AF-8D15-DA05-8A8F-3E920B2D6D90}"/>
              </a:ext>
            </a:extLst>
          </p:cNvPr>
          <p:cNvSpPr txBox="1"/>
          <p:nvPr/>
        </p:nvSpPr>
        <p:spPr>
          <a:xfrm>
            <a:off x="3707379" y="1424182"/>
            <a:ext cx="28430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488E3AF0-82DE-D890-962F-ED7A2CCD7999}"/>
              </a:ext>
            </a:extLst>
          </p:cNvPr>
          <p:cNvSpPr txBox="1"/>
          <p:nvPr/>
        </p:nvSpPr>
        <p:spPr>
          <a:xfrm>
            <a:off x="3686887" y="1646647"/>
            <a:ext cx="3048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C8140F49-5A6B-51E5-694E-F4AD610F2CD7}"/>
              </a:ext>
            </a:extLst>
          </p:cNvPr>
          <p:cNvSpPr txBox="1"/>
          <p:nvPr/>
        </p:nvSpPr>
        <p:spPr>
          <a:xfrm>
            <a:off x="3697452" y="1867603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66749DF2-9BD0-46AB-7471-7A1F39FF6158}"/>
              </a:ext>
            </a:extLst>
          </p:cNvPr>
          <p:cNvSpPr txBox="1"/>
          <p:nvPr/>
        </p:nvSpPr>
        <p:spPr>
          <a:xfrm>
            <a:off x="3716078" y="1313465"/>
            <a:ext cx="2771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81B7D5EB-25B1-30D1-96A0-0C6F9376EFE6}"/>
              </a:ext>
            </a:extLst>
          </p:cNvPr>
          <p:cNvSpPr txBox="1"/>
          <p:nvPr/>
        </p:nvSpPr>
        <p:spPr>
          <a:xfrm>
            <a:off x="3716078" y="1539324"/>
            <a:ext cx="2771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21764590-30D6-98F6-3469-7ECAC9290BC0}"/>
              </a:ext>
            </a:extLst>
          </p:cNvPr>
          <p:cNvSpPr txBox="1"/>
          <p:nvPr/>
        </p:nvSpPr>
        <p:spPr>
          <a:xfrm>
            <a:off x="3698429" y="1759073"/>
            <a:ext cx="29400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974BFD07-66F6-7229-1705-7A3599699B51}"/>
              </a:ext>
            </a:extLst>
          </p:cNvPr>
          <p:cNvSpPr txBox="1"/>
          <p:nvPr/>
        </p:nvSpPr>
        <p:spPr>
          <a:xfrm>
            <a:off x="3693802" y="1971747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9E40AFB7-E12A-FB4A-97F7-CEC519F0DA4F}"/>
              </a:ext>
            </a:extLst>
          </p:cNvPr>
          <p:cNvSpPr txBox="1"/>
          <p:nvPr/>
        </p:nvSpPr>
        <p:spPr>
          <a:xfrm>
            <a:off x="3696054" y="2086232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F52BE4F1-C036-8CFE-F997-9FA90E301DB3}"/>
              </a:ext>
            </a:extLst>
          </p:cNvPr>
          <p:cNvSpPr txBox="1"/>
          <p:nvPr/>
        </p:nvSpPr>
        <p:spPr>
          <a:xfrm>
            <a:off x="3783016" y="3215273"/>
            <a:ext cx="180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57EFD2D1-E125-BD88-40B9-61B86E17DFD6}"/>
              </a:ext>
            </a:extLst>
          </p:cNvPr>
          <p:cNvSpPr txBox="1"/>
          <p:nvPr/>
        </p:nvSpPr>
        <p:spPr>
          <a:xfrm>
            <a:off x="3692703" y="3331653"/>
            <a:ext cx="30241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6B4573A9-8E4D-B686-8D7B-407C840CBA58}"/>
              </a:ext>
            </a:extLst>
          </p:cNvPr>
          <p:cNvSpPr txBox="1"/>
          <p:nvPr/>
        </p:nvSpPr>
        <p:spPr>
          <a:xfrm>
            <a:off x="3725809" y="3439320"/>
            <a:ext cx="27278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86158121-5124-14CB-7F98-C3DF5B563425}"/>
              </a:ext>
            </a:extLst>
          </p:cNvPr>
          <p:cNvSpPr txBox="1"/>
          <p:nvPr/>
        </p:nvSpPr>
        <p:spPr>
          <a:xfrm>
            <a:off x="3713923" y="3658435"/>
            <a:ext cx="28430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71CA3376-5C25-AF90-D111-CE49B1E571BC}"/>
              </a:ext>
            </a:extLst>
          </p:cNvPr>
          <p:cNvSpPr txBox="1"/>
          <p:nvPr/>
        </p:nvSpPr>
        <p:spPr>
          <a:xfrm>
            <a:off x="3693431" y="3880900"/>
            <a:ext cx="3048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FBE17BEF-BDDE-6B11-8F47-A51687E76A67}"/>
              </a:ext>
            </a:extLst>
          </p:cNvPr>
          <p:cNvSpPr txBox="1"/>
          <p:nvPr/>
        </p:nvSpPr>
        <p:spPr>
          <a:xfrm>
            <a:off x="3703996" y="4101856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089E86C0-222A-02CE-2C83-08FCA0DCC95C}"/>
              </a:ext>
            </a:extLst>
          </p:cNvPr>
          <p:cNvSpPr txBox="1"/>
          <p:nvPr/>
        </p:nvSpPr>
        <p:spPr>
          <a:xfrm>
            <a:off x="3722622" y="3547718"/>
            <a:ext cx="2771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50F16429-3E1A-F9E4-6D88-D16FC53CD321}"/>
              </a:ext>
            </a:extLst>
          </p:cNvPr>
          <p:cNvSpPr txBox="1"/>
          <p:nvPr/>
        </p:nvSpPr>
        <p:spPr>
          <a:xfrm>
            <a:off x="3722622" y="3773577"/>
            <a:ext cx="2771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0039C161-CBDD-F708-BF9F-3D7C043C0A3F}"/>
              </a:ext>
            </a:extLst>
          </p:cNvPr>
          <p:cNvSpPr txBox="1"/>
          <p:nvPr/>
        </p:nvSpPr>
        <p:spPr>
          <a:xfrm>
            <a:off x="3704973" y="3993326"/>
            <a:ext cx="29400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71BAB0AC-20C4-B796-0113-61053EF8B906}"/>
              </a:ext>
            </a:extLst>
          </p:cNvPr>
          <p:cNvSpPr txBox="1"/>
          <p:nvPr/>
        </p:nvSpPr>
        <p:spPr>
          <a:xfrm>
            <a:off x="3700346" y="4206000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B6EBB5B0-5475-205F-822A-C71C40AA939D}"/>
              </a:ext>
            </a:extLst>
          </p:cNvPr>
          <p:cNvSpPr txBox="1"/>
          <p:nvPr/>
        </p:nvSpPr>
        <p:spPr>
          <a:xfrm>
            <a:off x="3702598" y="4320485"/>
            <a:ext cx="2956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AC2514A5-C61B-4248-987C-04D3C0EB542A}"/>
                  </a:ext>
                </a:extLst>
              </p:cNvPr>
              <p:cNvSpPr txBox="1"/>
              <p:nvPr/>
            </p:nvSpPr>
            <p:spPr>
              <a:xfrm rot="18857223">
                <a:off x="4913216" y="2275963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1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9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AC2514A5-C61B-4248-987C-04D3C0EB542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913216" y="2275963"/>
                <a:ext cx="614271" cy="169277"/>
              </a:xfrm>
              <a:prstGeom prst="rect">
                <a:avLst/>
              </a:prstGeom>
              <a:blipFill>
                <a:blip r:embed="rId6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A13A8C3E-3A8F-E297-ED64-F32033015E89}"/>
                  </a:ext>
                </a:extLst>
              </p:cNvPr>
              <p:cNvSpPr txBox="1"/>
              <p:nvPr/>
            </p:nvSpPr>
            <p:spPr>
              <a:xfrm rot="18857223">
                <a:off x="5486505" y="2280531"/>
                <a:ext cx="59824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5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8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A13A8C3E-3A8F-E297-ED64-F32033015E8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486505" y="2280531"/>
                <a:ext cx="598241" cy="169277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AD283A5C-C72D-30D2-0BE2-1E3D3C2EB1AF}"/>
                  </a:ext>
                </a:extLst>
              </p:cNvPr>
              <p:cNvSpPr txBox="1"/>
              <p:nvPr/>
            </p:nvSpPr>
            <p:spPr>
              <a:xfrm rot="18857223">
                <a:off x="5340896" y="2277452"/>
                <a:ext cx="59824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4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2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AD283A5C-C72D-30D2-0BE2-1E3D3C2EB1A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340896" y="2277452"/>
                <a:ext cx="598241" cy="169277"/>
              </a:xfrm>
              <a:prstGeom prst="rect">
                <a:avLst/>
              </a:prstGeom>
              <a:blipFill>
                <a:blip r:embed="rId8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DE7A35C2-0F97-6235-DDE1-ABF165E49140}"/>
                  </a:ext>
                </a:extLst>
              </p:cNvPr>
              <p:cNvSpPr txBox="1"/>
              <p:nvPr/>
            </p:nvSpPr>
            <p:spPr>
              <a:xfrm rot="18857223">
                <a:off x="5200528" y="2273853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3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4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DE7A35C2-0F97-6235-DDE1-ABF165E4914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200528" y="2273853"/>
                <a:ext cx="614271" cy="169277"/>
              </a:xfrm>
              <a:prstGeom prst="rect">
                <a:avLst/>
              </a:prstGeom>
              <a:blipFill>
                <a:blip r:embed="rId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8223BA0C-05A6-047C-9E96-D67EDDFE4938}"/>
                  </a:ext>
                </a:extLst>
              </p:cNvPr>
              <p:cNvSpPr txBox="1"/>
              <p:nvPr/>
            </p:nvSpPr>
            <p:spPr>
              <a:xfrm rot="18857223">
                <a:off x="5056869" y="2278166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2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8223BA0C-05A6-047C-9E96-D67EDDFE493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056869" y="2278166"/>
                <a:ext cx="614271" cy="169277"/>
              </a:xfrm>
              <a:prstGeom prst="rect">
                <a:avLst/>
              </a:prstGeom>
              <a:blipFill>
                <a:blip r:embed="rId1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1" name="テキスト ボックス 170">
                <a:extLst>
                  <a:ext uri="{FF2B5EF4-FFF2-40B4-BE49-F238E27FC236}">
                    <a16:creationId xmlns:a16="http://schemas.microsoft.com/office/drawing/2014/main" id="{148E54D9-424F-FF56-EEA0-8B6D8AF29DD6}"/>
                  </a:ext>
                </a:extLst>
              </p:cNvPr>
              <p:cNvSpPr txBox="1"/>
              <p:nvPr/>
            </p:nvSpPr>
            <p:spPr>
              <a:xfrm rot="18857223">
                <a:off x="4772193" y="2278758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0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4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1" name="テキスト ボックス 170">
                <a:extLst>
                  <a:ext uri="{FF2B5EF4-FFF2-40B4-BE49-F238E27FC236}">
                    <a16:creationId xmlns:a16="http://schemas.microsoft.com/office/drawing/2014/main" id="{148E54D9-424F-FF56-EEA0-8B6D8AF29DD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772193" y="2278758"/>
                <a:ext cx="614271" cy="169277"/>
              </a:xfrm>
              <a:prstGeom prst="rect">
                <a:avLst/>
              </a:prstGeom>
              <a:blipFill>
                <a:blip r:embed="rId11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070909AF-15A4-5DA0-530E-34E35268EBEA}"/>
                  </a:ext>
                </a:extLst>
              </p:cNvPr>
              <p:cNvSpPr txBox="1"/>
              <p:nvPr/>
            </p:nvSpPr>
            <p:spPr>
              <a:xfrm rot="18857223">
                <a:off x="4649996" y="2260379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9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9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070909AF-15A4-5DA0-530E-34E35268EBE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649996" y="2260379"/>
                <a:ext cx="582211" cy="169277"/>
              </a:xfrm>
              <a:prstGeom prst="rect">
                <a:avLst/>
              </a:prstGeom>
              <a:blipFill>
                <a:blip r:embed="rId1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0DA93D36-71E3-EECE-74C9-4B0A13173139}"/>
                  </a:ext>
                </a:extLst>
              </p:cNvPr>
              <p:cNvSpPr txBox="1"/>
              <p:nvPr/>
            </p:nvSpPr>
            <p:spPr>
              <a:xfrm rot="18857223">
                <a:off x="4509311" y="2268625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8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0DA93D36-71E3-EECE-74C9-4B0A1317313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509311" y="2268625"/>
                <a:ext cx="582211" cy="169277"/>
              </a:xfrm>
              <a:prstGeom prst="rect">
                <a:avLst/>
              </a:prstGeom>
              <a:blipFill>
                <a:blip r:embed="rId1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450F959D-D0BF-5FFE-86A8-151C6DCA92FD}"/>
                  </a:ext>
                </a:extLst>
              </p:cNvPr>
              <p:cNvSpPr txBox="1"/>
              <p:nvPr/>
            </p:nvSpPr>
            <p:spPr>
              <a:xfrm rot="18857223">
                <a:off x="4374995" y="2262957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7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4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450F959D-D0BF-5FFE-86A8-151C6DCA92F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374995" y="2262957"/>
                <a:ext cx="582211" cy="169277"/>
              </a:xfrm>
              <a:prstGeom prst="rect">
                <a:avLst/>
              </a:prstGeom>
              <a:blipFill>
                <a:blip r:embed="rId14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66B1ACF1-E788-2AF6-84F3-B132ED7776B9}"/>
                  </a:ext>
                </a:extLst>
              </p:cNvPr>
              <p:cNvSpPr txBox="1"/>
              <p:nvPr/>
            </p:nvSpPr>
            <p:spPr>
              <a:xfrm rot="18857223">
                <a:off x="4231469" y="2259835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6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66B1ACF1-E788-2AF6-84F3-B132ED7776B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231469" y="2259835"/>
                <a:ext cx="582211" cy="169277"/>
              </a:xfrm>
              <a:prstGeom prst="rect">
                <a:avLst/>
              </a:prstGeom>
              <a:blipFill>
                <a:blip r:embed="rId15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6" name="テキスト ボックス 175">
                <a:extLst>
                  <a:ext uri="{FF2B5EF4-FFF2-40B4-BE49-F238E27FC236}">
                    <a16:creationId xmlns:a16="http://schemas.microsoft.com/office/drawing/2014/main" id="{55325DF8-21F7-FA79-2F7D-925FAB7D7E9A}"/>
                  </a:ext>
                </a:extLst>
              </p:cNvPr>
              <p:cNvSpPr txBox="1"/>
              <p:nvPr/>
            </p:nvSpPr>
            <p:spPr>
              <a:xfrm rot="18857223">
                <a:off x="4084306" y="2260380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5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3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6" name="テキスト ボックス 175">
                <a:extLst>
                  <a:ext uri="{FF2B5EF4-FFF2-40B4-BE49-F238E27FC236}">
                    <a16:creationId xmlns:a16="http://schemas.microsoft.com/office/drawing/2014/main" id="{55325DF8-21F7-FA79-2F7D-925FAB7D7E9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084306" y="2260380"/>
                <a:ext cx="582211" cy="169277"/>
              </a:xfrm>
              <a:prstGeom prst="rect">
                <a:avLst/>
              </a:prstGeom>
              <a:blipFill>
                <a:blip r:embed="rId16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7" name="テキスト ボックス 176">
                <a:extLst>
                  <a:ext uri="{FF2B5EF4-FFF2-40B4-BE49-F238E27FC236}">
                    <a16:creationId xmlns:a16="http://schemas.microsoft.com/office/drawing/2014/main" id="{365536E4-8FA7-C27D-4D27-0B9628D0913C}"/>
                  </a:ext>
                </a:extLst>
              </p:cNvPr>
              <p:cNvSpPr txBox="1"/>
              <p:nvPr/>
            </p:nvSpPr>
            <p:spPr>
              <a:xfrm rot="18857223">
                <a:off x="3936489" y="2267185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4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3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7" name="テキスト ボックス 176">
                <a:extLst>
                  <a:ext uri="{FF2B5EF4-FFF2-40B4-BE49-F238E27FC236}">
                    <a16:creationId xmlns:a16="http://schemas.microsoft.com/office/drawing/2014/main" id="{365536E4-8FA7-C27D-4D27-0B9628D0913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3936489" y="2267185"/>
                <a:ext cx="582211" cy="169277"/>
              </a:xfrm>
              <a:prstGeom prst="rect">
                <a:avLst/>
              </a:prstGeom>
              <a:blipFill>
                <a:blip r:embed="rId1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8" name="テキスト ボックス 177">
                <a:extLst>
                  <a:ext uri="{FF2B5EF4-FFF2-40B4-BE49-F238E27FC236}">
                    <a16:creationId xmlns:a16="http://schemas.microsoft.com/office/drawing/2014/main" id="{7D0E99CA-47A5-E15B-399E-F465ED183DE4}"/>
                  </a:ext>
                </a:extLst>
              </p:cNvPr>
              <p:cNvSpPr txBox="1"/>
              <p:nvPr/>
            </p:nvSpPr>
            <p:spPr>
              <a:xfrm rot="18857223">
                <a:off x="3804355" y="2263750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2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8" name="テキスト ボックス 177">
                <a:extLst>
                  <a:ext uri="{FF2B5EF4-FFF2-40B4-BE49-F238E27FC236}">
                    <a16:creationId xmlns:a16="http://schemas.microsoft.com/office/drawing/2014/main" id="{7D0E99CA-47A5-E15B-399E-F465ED183DE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3804355" y="2263750"/>
                <a:ext cx="582211" cy="169277"/>
              </a:xfrm>
              <a:prstGeom prst="rect">
                <a:avLst/>
              </a:prstGeom>
              <a:blipFill>
                <a:blip r:embed="rId18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9" name="テキスト ボックス 178">
                <a:extLst>
                  <a:ext uri="{FF2B5EF4-FFF2-40B4-BE49-F238E27FC236}">
                    <a16:creationId xmlns:a16="http://schemas.microsoft.com/office/drawing/2014/main" id="{FE0F5AAC-7050-D2CA-61D4-7431B4FEB830}"/>
                  </a:ext>
                </a:extLst>
              </p:cNvPr>
              <p:cNvSpPr txBox="1"/>
              <p:nvPr/>
            </p:nvSpPr>
            <p:spPr>
              <a:xfrm rot="18857223">
                <a:off x="3625885" y="2279218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2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79" name="テキスト ボックス 178">
                <a:extLst>
                  <a:ext uri="{FF2B5EF4-FFF2-40B4-BE49-F238E27FC236}">
                    <a16:creationId xmlns:a16="http://schemas.microsoft.com/office/drawing/2014/main" id="{FE0F5AAC-7050-D2CA-61D4-7431B4FEB83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3625885" y="2279218"/>
                <a:ext cx="614271" cy="169277"/>
              </a:xfrm>
              <a:prstGeom prst="rect">
                <a:avLst/>
              </a:prstGeom>
              <a:blipFill>
                <a:blip r:embed="rId1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0" name="テキスト ボックス 179">
                <a:extLst>
                  <a:ext uri="{FF2B5EF4-FFF2-40B4-BE49-F238E27FC236}">
                    <a16:creationId xmlns:a16="http://schemas.microsoft.com/office/drawing/2014/main" id="{B53352D7-7151-15BC-C9E0-16D42A289C0C}"/>
                  </a:ext>
                </a:extLst>
              </p:cNvPr>
              <p:cNvSpPr txBox="1"/>
              <p:nvPr/>
            </p:nvSpPr>
            <p:spPr>
              <a:xfrm rot="18857223">
                <a:off x="5630525" y="2271854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6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4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80" name="テキスト ボックス 179">
                <a:extLst>
                  <a:ext uri="{FF2B5EF4-FFF2-40B4-BE49-F238E27FC236}">
                    <a16:creationId xmlns:a16="http://schemas.microsoft.com/office/drawing/2014/main" id="{B53352D7-7151-15BC-C9E0-16D42A289C0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630525" y="2271854"/>
                <a:ext cx="614271" cy="169277"/>
              </a:xfrm>
              <a:prstGeom prst="rect">
                <a:avLst/>
              </a:prstGeom>
              <a:blipFill>
                <a:blip r:embed="rId2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76833841-2BF9-B0D9-2465-C090DAF9CFA6}"/>
                  </a:ext>
                </a:extLst>
              </p:cNvPr>
              <p:cNvSpPr txBox="1"/>
              <p:nvPr/>
            </p:nvSpPr>
            <p:spPr>
              <a:xfrm rot="18857223">
                <a:off x="5763432" y="2284325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1" lang="en-US" altLang="ja-JP" sz="5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 yrs 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3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76833841-2BF9-B0D9-2465-C090DAF9CFA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763432" y="2284325"/>
                <a:ext cx="614271" cy="169277"/>
              </a:xfrm>
              <a:prstGeom prst="rect">
                <a:avLst/>
              </a:prstGeom>
              <a:blipFill>
                <a:blip r:embed="rId21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1A95B948-0183-7B60-A74D-B87C02636F87}"/>
                  </a:ext>
                </a:extLst>
              </p:cNvPr>
              <p:cNvSpPr txBox="1"/>
              <p:nvPr/>
            </p:nvSpPr>
            <p:spPr>
              <a:xfrm rot="18857223">
                <a:off x="4870432" y="4519073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1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9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1A95B948-0183-7B60-A74D-B87C02636F8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870432" y="4519073"/>
                <a:ext cx="614271" cy="169277"/>
              </a:xfrm>
              <a:prstGeom prst="rect">
                <a:avLst/>
              </a:prstGeom>
              <a:blipFill>
                <a:blip r:embed="rId2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5" name="テキスト ボックス 184">
                <a:extLst>
                  <a:ext uri="{FF2B5EF4-FFF2-40B4-BE49-F238E27FC236}">
                    <a16:creationId xmlns:a16="http://schemas.microsoft.com/office/drawing/2014/main" id="{0B770CC7-F689-6592-3E7C-E600BDF4BF16}"/>
                  </a:ext>
                </a:extLst>
              </p:cNvPr>
              <p:cNvSpPr txBox="1"/>
              <p:nvPr/>
            </p:nvSpPr>
            <p:spPr>
              <a:xfrm rot="18857223">
                <a:off x="5443721" y="4523641"/>
                <a:ext cx="59824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5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8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85" name="テキスト ボックス 184">
                <a:extLst>
                  <a:ext uri="{FF2B5EF4-FFF2-40B4-BE49-F238E27FC236}">
                    <a16:creationId xmlns:a16="http://schemas.microsoft.com/office/drawing/2014/main" id="{0B770CC7-F689-6592-3E7C-E600BDF4BF1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443721" y="4523641"/>
                <a:ext cx="598241" cy="169277"/>
              </a:xfrm>
              <a:prstGeom prst="rect">
                <a:avLst/>
              </a:prstGeom>
              <a:blipFill>
                <a:blip r:embed="rId2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C5EEFA97-C60A-8308-6E69-87ABD0D9F59F}"/>
                  </a:ext>
                </a:extLst>
              </p:cNvPr>
              <p:cNvSpPr txBox="1"/>
              <p:nvPr/>
            </p:nvSpPr>
            <p:spPr>
              <a:xfrm rot="18857223">
                <a:off x="5298112" y="4520562"/>
                <a:ext cx="59824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4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2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C5EEFA97-C60A-8308-6E69-87ABD0D9F59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298112" y="4520562"/>
                <a:ext cx="598241" cy="169277"/>
              </a:xfrm>
              <a:prstGeom prst="rect">
                <a:avLst/>
              </a:prstGeom>
              <a:blipFill>
                <a:blip r:embed="rId24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7" name="テキスト ボックス 186">
                <a:extLst>
                  <a:ext uri="{FF2B5EF4-FFF2-40B4-BE49-F238E27FC236}">
                    <a16:creationId xmlns:a16="http://schemas.microsoft.com/office/drawing/2014/main" id="{FD929C66-6E79-84A7-B3FE-230E5A557482}"/>
                  </a:ext>
                </a:extLst>
              </p:cNvPr>
              <p:cNvSpPr txBox="1"/>
              <p:nvPr/>
            </p:nvSpPr>
            <p:spPr>
              <a:xfrm rot="18857223">
                <a:off x="5157744" y="4516963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3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4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87" name="テキスト ボックス 186">
                <a:extLst>
                  <a:ext uri="{FF2B5EF4-FFF2-40B4-BE49-F238E27FC236}">
                    <a16:creationId xmlns:a16="http://schemas.microsoft.com/office/drawing/2014/main" id="{FD929C66-6E79-84A7-B3FE-230E5A557482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157744" y="4516963"/>
                <a:ext cx="614271" cy="169277"/>
              </a:xfrm>
              <a:prstGeom prst="rect">
                <a:avLst/>
              </a:prstGeom>
              <a:blipFill>
                <a:blip r:embed="rId25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88229275-8A3A-EBA0-AD99-B4BF4CB2EC82}"/>
                  </a:ext>
                </a:extLst>
              </p:cNvPr>
              <p:cNvSpPr txBox="1"/>
              <p:nvPr/>
            </p:nvSpPr>
            <p:spPr>
              <a:xfrm rot="18857223">
                <a:off x="5014085" y="4521276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2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88229275-8A3A-EBA0-AD99-B4BF4CB2EC82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014085" y="4521276"/>
                <a:ext cx="614271" cy="169277"/>
              </a:xfrm>
              <a:prstGeom prst="rect">
                <a:avLst/>
              </a:prstGeom>
              <a:blipFill>
                <a:blip r:embed="rId26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4DAEBFCC-A8D5-8778-9B77-6C3282663B65}"/>
                  </a:ext>
                </a:extLst>
              </p:cNvPr>
              <p:cNvSpPr txBox="1"/>
              <p:nvPr/>
            </p:nvSpPr>
            <p:spPr>
              <a:xfrm rot="18857223">
                <a:off x="4729409" y="4521868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0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4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4DAEBFCC-A8D5-8778-9B77-6C3282663B6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729409" y="4521868"/>
                <a:ext cx="614271" cy="169277"/>
              </a:xfrm>
              <a:prstGeom prst="rect">
                <a:avLst/>
              </a:prstGeom>
              <a:blipFill>
                <a:blip r:embed="rId2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id="{6DC764BD-D53C-2376-4D13-9A8F7E8F425E}"/>
                  </a:ext>
                </a:extLst>
              </p:cNvPr>
              <p:cNvSpPr txBox="1"/>
              <p:nvPr/>
            </p:nvSpPr>
            <p:spPr>
              <a:xfrm rot="18857223">
                <a:off x="4607212" y="4503489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9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9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id="{6DC764BD-D53C-2376-4D13-9A8F7E8F425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607212" y="4503489"/>
                <a:ext cx="582211" cy="169277"/>
              </a:xfrm>
              <a:prstGeom prst="rect">
                <a:avLst/>
              </a:prstGeom>
              <a:blipFill>
                <a:blip r:embed="rId28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1" name="テキスト ボックス 190">
                <a:extLst>
                  <a:ext uri="{FF2B5EF4-FFF2-40B4-BE49-F238E27FC236}">
                    <a16:creationId xmlns:a16="http://schemas.microsoft.com/office/drawing/2014/main" id="{0EAAC17C-67DD-D6B3-ADC4-F9F17F52037B}"/>
                  </a:ext>
                </a:extLst>
              </p:cNvPr>
              <p:cNvSpPr txBox="1"/>
              <p:nvPr/>
            </p:nvSpPr>
            <p:spPr>
              <a:xfrm rot="18857223">
                <a:off x="4466527" y="4511735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8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1" name="テキスト ボックス 190">
                <a:extLst>
                  <a:ext uri="{FF2B5EF4-FFF2-40B4-BE49-F238E27FC236}">
                    <a16:creationId xmlns:a16="http://schemas.microsoft.com/office/drawing/2014/main" id="{0EAAC17C-67DD-D6B3-ADC4-F9F17F52037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466527" y="4511735"/>
                <a:ext cx="582211" cy="169277"/>
              </a:xfrm>
              <a:prstGeom prst="rect">
                <a:avLst/>
              </a:prstGeom>
              <a:blipFill>
                <a:blip r:embed="rId2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4C3E1178-F3D1-BC15-48B2-A54116626410}"/>
                  </a:ext>
                </a:extLst>
              </p:cNvPr>
              <p:cNvSpPr txBox="1"/>
              <p:nvPr/>
            </p:nvSpPr>
            <p:spPr>
              <a:xfrm rot="18857223">
                <a:off x="4332211" y="4506067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7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4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id="{4C3E1178-F3D1-BC15-48B2-A5411662641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332211" y="4506067"/>
                <a:ext cx="582211" cy="169277"/>
              </a:xfrm>
              <a:prstGeom prst="rect">
                <a:avLst/>
              </a:prstGeom>
              <a:blipFill>
                <a:blip r:embed="rId3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1CA00720-2DD0-B71C-2229-145C24148689}"/>
                  </a:ext>
                </a:extLst>
              </p:cNvPr>
              <p:cNvSpPr txBox="1"/>
              <p:nvPr/>
            </p:nvSpPr>
            <p:spPr>
              <a:xfrm rot="18857223">
                <a:off x="4188685" y="4502945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6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1CA00720-2DD0-B71C-2229-145C2414868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188685" y="4502945"/>
                <a:ext cx="582211" cy="169277"/>
              </a:xfrm>
              <a:prstGeom prst="rect">
                <a:avLst/>
              </a:prstGeom>
              <a:blipFill>
                <a:blip r:embed="rId31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4" name="テキスト ボックス 193">
                <a:extLst>
                  <a:ext uri="{FF2B5EF4-FFF2-40B4-BE49-F238E27FC236}">
                    <a16:creationId xmlns:a16="http://schemas.microsoft.com/office/drawing/2014/main" id="{FFE5FA80-75BB-99F6-6219-5981345FB00E}"/>
                  </a:ext>
                </a:extLst>
              </p:cNvPr>
              <p:cNvSpPr txBox="1"/>
              <p:nvPr/>
            </p:nvSpPr>
            <p:spPr>
              <a:xfrm rot="18857223">
                <a:off x="4041522" y="4503490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5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3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4" name="テキスト ボックス 193">
                <a:extLst>
                  <a:ext uri="{FF2B5EF4-FFF2-40B4-BE49-F238E27FC236}">
                    <a16:creationId xmlns:a16="http://schemas.microsoft.com/office/drawing/2014/main" id="{FFE5FA80-75BB-99F6-6219-5981345FB00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4041522" y="4503490"/>
                <a:ext cx="582211" cy="169277"/>
              </a:xfrm>
              <a:prstGeom prst="rect">
                <a:avLst/>
              </a:prstGeom>
              <a:blipFill>
                <a:blip r:embed="rId3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5" name="テキスト ボックス 194">
                <a:extLst>
                  <a:ext uri="{FF2B5EF4-FFF2-40B4-BE49-F238E27FC236}">
                    <a16:creationId xmlns:a16="http://schemas.microsoft.com/office/drawing/2014/main" id="{700C01E7-08A8-D666-4B62-F52B5823AFE7}"/>
                  </a:ext>
                </a:extLst>
              </p:cNvPr>
              <p:cNvSpPr txBox="1"/>
              <p:nvPr/>
            </p:nvSpPr>
            <p:spPr>
              <a:xfrm rot="18857223">
                <a:off x="3893705" y="4510295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4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3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5" name="テキスト ボックス 194">
                <a:extLst>
                  <a:ext uri="{FF2B5EF4-FFF2-40B4-BE49-F238E27FC236}">
                    <a16:creationId xmlns:a16="http://schemas.microsoft.com/office/drawing/2014/main" id="{700C01E7-08A8-D666-4B62-F52B5823AFE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3893705" y="4510295"/>
                <a:ext cx="582211" cy="169277"/>
              </a:xfrm>
              <a:prstGeom prst="rect">
                <a:avLst/>
              </a:prstGeom>
              <a:blipFill>
                <a:blip r:embed="rId3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6" name="テキスト ボックス 195">
                <a:extLst>
                  <a:ext uri="{FF2B5EF4-FFF2-40B4-BE49-F238E27FC236}">
                    <a16:creationId xmlns:a16="http://schemas.microsoft.com/office/drawing/2014/main" id="{2CBC9C29-0C38-0DF5-BD4A-288C06BF44D5}"/>
                  </a:ext>
                </a:extLst>
              </p:cNvPr>
              <p:cNvSpPr txBox="1"/>
              <p:nvPr/>
            </p:nvSpPr>
            <p:spPr>
              <a:xfrm rot="18857223">
                <a:off x="3761571" y="4506860"/>
                <a:ext cx="5822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2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6" name="テキスト ボックス 195">
                <a:extLst>
                  <a:ext uri="{FF2B5EF4-FFF2-40B4-BE49-F238E27FC236}">
                    <a16:creationId xmlns:a16="http://schemas.microsoft.com/office/drawing/2014/main" id="{2CBC9C29-0C38-0DF5-BD4A-288C06BF44D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3761571" y="4506860"/>
                <a:ext cx="582211" cy="169277"/>
              </a:xfrm>
              <a:prstGeom prst="rect">
                <a:avLst/>
              </a:prstGeom>
              <a:blipFill>
                <a:blip r:embed="rId34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7" name="テキスト ボックス 196">
                <a:extLst>
                  <a:ext uri="{FF2B5EF4-FFF2-40B4-BE49-F238E27FC236}">
                    <a16:creationId xmlns:a16="http://schemas.microsoft.com/office/drawing/2014/main" id="{CC89F58A-1D22-4A98-2B05-C36A44A9EE93}"/>
                  </a:ext>
                </a:extLst>
              </p:cNvPr>
              <p:cNvSpPr txBox="1"/>
              <p:nvPr/>
            </p:nvSpPr>
            <p:spPr>
              <a:xfrm rot="18857223">
                <a:off x="3583101" y="4522328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2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7" name="テキスト ボックス 196">
                <a:extLst>
                  <a:ext uri="{FF2B5EF4-FFF2-40B4-BE49-F238E27FC236}">
                    <a16:creationId xmlns:a16="http://schemas.microsoft.com/office/drawing/2014/main" id="{CC89F58A-1D22-4A98-2B05-C36A44A9EE9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3583101" y="4522328"/>
                <a:ext cx="614271" cy="169277"/>
              </a:xfrm>
              <a:prstGeom prst="rect">
                <a:avLst/>
              </a:prstGeom>
              <a:blipFill>
                <a:blip r:embed="rId35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0A674919-67D8-B18C-3CDE-BCF17ADE7B6C}"/>
                  </a:ext>
                </a:extLst>
              </p:cNvPr>
              <p:cNvSpPr txBox="1"/>
              <p:nvPr/>
            </p:nvSpPr>
            <p:spPr>
              <a:xfrm rot="18857223">
                <a:off x="5587741" y="4514964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6 yrs 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4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0A674919-67D8-B18C-3CDE-BCF17ADE7B6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587741" y="4514964"/>
                <a:ext cx="614271" cy="169277"/>
              </a:xfrm>
              <a:prstGeom prst="rect">
                <a:avLst/>
              </a:prstGeom>
              <a:blipFill>
                <a:blip r:embed="rId36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832BBDBA-8663-1515-5574-31CFD969B285}"/>
                  </a:ext>
                </a:extLst>
              </p:cNvPr>
              <p:cNvSpPr txBox="1"/>
              <p:nvPr/>
            </p:nvSpPr>
            <p:spPr>
              <a:xfrm rot="18857223">
                <a:off x="5720648" y="4527435"/>
                <a:ext cx="61427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kumimoji="1" lang="en-US" altLang="ja-JP" sz="50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1" lang="en-US" altLang="ja-JP" sz="5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 yrs 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=</a:t>
                </a:r>
                <a:r>
                  <a:rPr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3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832BBDBA-8663-1515-5574-31CFD969B28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8857223">
                <a:off x="5720648" y="4527435"/>
                <a:ext cx="614271" cy="169277"/>
              </a:xfrm>
              <a:prstGeom prst="rect">
                <a:avLst/>
              </a:prstGeom>
              <a:blipFill>
                <a:blip r:embed="rId3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4070247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85</TotalTime>
  <Words>607</Words>
  <Application>Microsoft Office PowerPoint</Application>
  <PresentationFormat>A4 210 x 297 mm</PresentationFormat>
  <Paragraphs>1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Cambria Math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田 夏樹</dc:creator>
  <cp:lastModifiedBy>夏樹 石田</cp:lastModifiedBy>
  <cp:revision>84</cp:revision>
  <dcterms:created xsi:type="dcterms:W3CDTF">2020-11-30T14:45:54Z</dcterms:created>
  <dcterms:modified xsi:type="dcterms:W3CDTF">2025-03-27T12:16:05Z</dcterms:modified>
</cp:coreProperties>
</file>